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37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0E57C-9E87-7C12-670A-045C76A6CE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5343C0A-CF27-E6D5-C7DF-12C96862FE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92E73D-4662-BAC5-DCC0-CB34DB916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B881EF-4AC9-323A-795E-E310A953C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E75BFC-2760-5D86-9B8D-0DD910507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648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9CE0F-83BD-7F24-42DE-5847B7E19B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0E81C1-C08D-B492-0D2F-AFC16EA8A5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E54EA7-C87D-1BFC-DEE5-D98FE6220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2288DE-4FC2-7478-0EA9-5A9E1EB84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C3532B-8000-D094-4F2D-E934FA1DC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976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D013F8-8845-C0BF-2D6C-DB03208973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364AC9-954B-7428-DFD2-1EDE8E8BE9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FEF51C-6AFA-C96B-B949-E133565A8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8CD8A8-5BD1-A734-FC71-AA5763F2D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111A48-AD66-6D7B-B0A2-1DFE0909C0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496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AA4D7D-B03A-F3D8-37AC-2EDB2968FF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5554A0-B7AD-1F47-3208-CE1DA41B8D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2A0C17-5388-672E-0C23-CADF99377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DC8AE8-652C-9978-9EB5-0528377F5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FF33E5-5583-57C3-1F52-76B72E5CFD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056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23106F-F17D-A67F-B4F0-878CCA0867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F9CCDF-0CDD-3F7E-90E1-85A84FB375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5CEEF9-7C47-5A07-C945-6DB495C25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AD70E7-0245-B0E6-54AE-F8C8963A5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90F2C6-AC8F-B3FE-1818-ADF7BC57D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867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814B34-04B0-3C77-DE78-1E8ADA815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FFBCA1-8342-27D6-3FA1-6CCCF346D4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E5F7FC-1EAE-D1CA-8554-F2864A0099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D577A5-75DB-C855-FF35-88A165A4B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8AB8DD-BCE0-F4A2-00B8-8C89F8537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98D150-3BF6-E872-4B5E-8F4CDE436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842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711C67-EAE3-B0D5-B166-952E0CEFB4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6CC26E-1140-C4C5-99B6-6FCE01B2F9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A3E744-A308-3289-270E-4A7449CD03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94E5F8-5F96-AF51-9350-A35D0DDE6D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B1A0454-0877-93CF-F7F6-A5EE0F7C8F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F0BFE5-9DD7-1C24-62D9-8D87B39A60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F7C54C8-AA07-B382-ADFF-D5ACE05959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AD289D8-FE05-F016-0320-23E030D19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864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92706C-D4B3-A8DE-8827-7E1D1E6CF4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2036F5A-4B2D-F7BC-A232-DE70D7307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9BA447-A437-5CFF-1295-75421103A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8B7FAD-1CD6-7088-7549-02A5C00F2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331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1841B5-AB8F-BFDA-5FAC-6BB3C3C74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27C5EF-EAB9-97FF-C7C5-CEC1F3673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557A1E-108F-3D81-7688-412A9DB35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616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8F924-97DF-250E-BDA4-C546B33AFA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7F310F-C665-1CFA-A88B-B878690704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52F12D-1DF6-9ADE-4FE5-A40F803A07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59251F-C6FB-9602-5F85-37BFDD020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585466-7974-B846-2CC8-3E7069D29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F51CC8-2704-8E53-4C44-122E66E97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988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046580-83DF-ABAE-92F2-5C7A899EA4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F13C83-852E-5203-2BFF-56893A78D2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0ACBAA-1A27-F591-9275-F294DD9E60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88AB3E-B727-FCD0-34F4-96906A99D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DC78BE-C78E-CD91-1EB5-EE78F9E3C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A63C3E-C61B-D4C9-6D46-2E69E87A18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597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8F5C0B-3243-4CC3-3E61-3CE73968A0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5057A9-F212-217B-E413-7491B987F3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81E1E9-F7AE-72F8-BBAB-BB68473DB5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540B73-03F2-4A7F-9DF6-3FF7EE6CBD3F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FAEBDC-9A90-D575-45A3-126461F1E2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86C6B5-86D0-5509-C62D-F266358F8D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A3EABD-4871-4A54-9F14-37868EEAB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604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39604CE-4133-4E23-A5C1-8A881CB7F5CA}"/>
              </a:ext>
            </a:extLst>
          </p:cNvPr>
          <p:cNvGrpSpPr/>
          <p:nvPr/>
        </p:nvGrpSpPr>
        <p:grpSpPr>
          <a:xfrm>
            <a:off x="1354349" y="544601"/>
            <a:ext cx="8419379" cy="6362415"/>
            <a:chOff x="1354349" y="544601"/>
            <a:chExt cx="8419379" cy="636241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9D4F270-0F62-8F5F-3098-5CE21A1C8C1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54349" y="544601"/>
              <a:ext cx="7910422" cy="5768797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E2749AD-349A-0E9A-2BB3-7FEFA74D628E}"/>
                </a:ext>
              </a:extLst>
            </p:cNvPr>
            <p:cNvSpPr txBox="1"/>
            <p:nvPr/>
          </p:nvSpPr>
          <p:spPr>
            <a:xfrm>
              <a:off x="1354349" y="6260685"/>
              <a:ext cx="841937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upplementary File 2:  Rotavirus genotypes by region.    Showing the overall genotypes frequency in each region as defined by color code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1537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</TotalTime>
  <Words>2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13592</dc:creator>
  <cp:lastModifiedBy>13592</cp:lastModifiedBy>
  <cp:revision>7</cp:revision>
  <dcterms:created xsi:type="dcterms:W3CDTF">2023-03-29T12:29:51Z</dcterms:created>
  <dcterms:modified xsi:type="dcterms:W3CDTF">2023-10-13T13:16:18Z</dcterms:modified>
</cp:coreProperties>
</file>